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-3156" y="-91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xmlns="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xmlns="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xmlns="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xmlns="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xmlns="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xmlns="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xmlns="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xmlns="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xmlns="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xmlns="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xmlns="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xmlns="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xmlns="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xmlns="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xmlns="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xmlns="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xmlns="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xmlns="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xmlns="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xmlns="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7" y="99951"/>
            <a:ext cx="8923783" cy="476123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arative analysis of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H(6-9)PGP action versus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max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ctio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n th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nscriptome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f th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C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t 24h and 4.5h afte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ru-RU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ru-R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334001"/>
            <a:ext cx="8862822" cy="152400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results of IA4.5-f vs. IS4.5-f (4.5h afte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were obtained previously (see ref. [20] in main manuscript file). (A) Venn diagram present comparison between the RNA-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results for the IA24-f vs. IS24-f (24 h afte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IA4.5-f vs. IS4.5-f (4.5h after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pairwise comparisons. (B) Eight DEGs that lie within the gene sets in the Venn diagram among the overlapping section. Only those genes with cut-off &gt;1.5 and </a:t>
            </a:r>
            <a:r>
              <a:rPr lang="en-US" sz="14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 (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Hierarchical cluster analysis of DEGs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n IA24-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S24-f as well as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IA4.5-f vs. IS4.5-f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pairwis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mparisons)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Each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ow represents a DEG; n = 3 per group. Only those genes with cut-off &gt;1.5 and </a:t>
            </a:r>
            <a:r>
              <a:rPr lang="en-US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</a:p>
          <a:p>
            <a:pPr marL="0" indent="0">
              <a:buNone/>
            </a:pPr>
            <a:endParaRPr lang="en-US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7" name="Picture 3" descr="K:\Редактируемые\Для публикаций\0_текущие публикации\ишемия_2\кора\статья по 24 часам DRFC\вар1\2_FBS\s5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0484" y="679742"/>
            <a:ext cx="6736715" cy="45790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176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5. Comparative analysis of ACTH(6-9)PGP action versus Semax action on the transcriptome of the FC at 24h and 4.5h after tMCAO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17</cp:revision>
  <dcterms:created xsi:type="dcterms:W3CDTF">2023-01-16T11:00:34Z</dcterms:created>
  <dcterms:modified xsi:type="dcterms:W3CDTF">2024-11-11T09:00:56Z</dcterms:modified>
</cp:coreProperties>
</file>